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080000" y="742951"/>
          <a:ext cx="2370666" cy="4755281"/>
        </p:xfrm>
        <a:graphic>
          <a:graphicData uri="http://schemas.openxmlformats.org/drawingml/2006/table">
            <a:tbl>
              <a:tblPr/>
              <a:tblGrid>
                <a:gridCol w="395111"/>
                <a:gridCol w="395111"/>
                <a:gridCol w="395111"/>
                <a:gridCol w="395111"/>
                <a:gridCol w="395111"/>
                <a:gridCol w="395111"/>
              </a:tblGrid>
              <a:tr h="3136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B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G </a:t>
                      </a:r>
                      <a:r>
                        <a:rPr lang="en-IN" sz="6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6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6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22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7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97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43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6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26737" marR="2673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7" name="Picture 6" descr="Bubble_plot_gen_sigf_cssna15.png"/>
          <p:cNvPicPr>
            <a:picLocks noChangeAspect="1"/>
          </p:cNvPicPr>
          <p:nvPr/>
        </p:nvPicPr>
        <p:blipFill>
          <a:blip r:embed="rId2" cstate="print"/>
          <a:srcRect r="20454"/>
          <a:stretch>
            <a:fillRect/>
          </a:stretch>
        </p:blipFill>
        <p:spPr>
          <a:xfrm>
            <a:off x="381000" y="990600"/>
            <a:ext cx="4673609" cy="4800610"/>
          </a:xfrm>
          <a:prstGeom prst="rect">
            <a:avLst/>
          </a:prstGeom>
        </p:spPr>
      </p:pic>
      <p:pic>
        <p:nvPicPr>
          <p:cNvPr id="8" name="Picture 7" descr="Bubble_plot_gen_sigf_cssna15.png"/>
          <p:cNvPicPr>
            <a:picLocks noChangeAspect="1"/>
          </p:cNvPicPr>
          <p:nvPr/>
        </p:nvPicPr>
        <p:blipFill>
          <a:blip r:embed="rId3" cstate="print"/>
          <a:srcRect l="79545" t="10714" b="16667"/>
          <a:stretch>
            <a:fillRect/>
          </a:stretch>
        </p:blipFill>
        <p:spPr>
          <a:xfrm>
            <a:off x="7543800" y="1752600"/>
            <a:ext cx="914409" cy="3486150"/>
          </a:xfrm>
          <a:prstGeom prst="rect">
            <a:avLst/>
          </a:prstGeom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762000" y="5867400"/>
            <a:ext cx="667612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 S4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ifferential abundance of gut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icrobiot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in different breeds or line at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genus level. Genera with significant (P&lt;0.05) difference in relative abundance among groups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identified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edge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were plotted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65</Words>
  <Application>Microsoft Office PowerPoint</Application>
  <PresentationFormat>On-screen Show 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7</cp:revision>
  <dcterms:created xsi:type="dcterms:W3CDTF">2006-08-16T00:00:00Z</dcterms:created>
  <dcterms:modified xsi:type="dcterms:W3CDTF">2020-12-20T12:54:42Z</dcterms:modified>
</cp:coreProperties>
</file>